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73"/>
    <a:srgbClr val="BFBFBF"/>
    <a:srgbClr val="8D8DFF"/>
    <a:srgbClr val="4FB6E9"/>
    <a:srgbClr val="9001D4"/>
    <a:srgbClr val="019E73"/>
    <a:srgbClr val="000080"/>
    <a:srgbClr val="C8D1E2"/>
    <a:srgbClr val="FFFFFF"/>
    <a:srgbClr val="90BF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–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 autoAdjust="0"/>
    <p:restoredTop sz="94384" autoAdjust="0"/>
  </p:normalViewPr>
  <p:slideViewPr>
    <p:cSldViewPr snapToGrid="0">
      <p:cViewPr varScale="1">
        <p:scale>
          <a:sx n="84" d="100"/>
          <a:sy n="84" d="100"/>
        </p:scale>
        <p:origin x="3848" y="1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3D69F-7222-B14D-9E01-39F81D144C7F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E3D8AD-4781-4F42-A424-48FC4D64EB44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76326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76817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182891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33420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0135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81604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41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31247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2942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8387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17488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3391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7436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FF063E1-7751-BA77-AE1F-922DA88E1C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2025122"/>
              </p:ext>
            </p:extLst>
          </p:nvPr>
        </p:nvGraphicFramePr>
        <p:xfrm>
          <a:off x="389198" y="831103"/>
          <a:ext cx="6079604" cy="767156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48921">
                  <a:extLst>
                    <a:ext uri="{9D8B030D-6E8A-4147-A177-3AD203B41FA5}">
                      <a16:colId xmlns:a16="http://schemas.microsoft.com/office/drawing/2014/main" val="1320340039"/>
                    </a:ext>
                  </a:extLst>
                </a:gridCol>
                <a:gridCol w="2430683">
                  <a:extLst>
                    <a:ext uri="{9D8B030D-6E8A-4147-A177-3AD203B41FA5}">
                      <a16:colId xmlns:a16="http://schemas.microsoft.com/office/drawing/2014/main" val="3015937034"/>
                    </a:ext>
                  </a:extLst>
                </a:gridCol>
              </a:tblGrid>
              <a:tr h="320803">
                <a:tc gridSpan="2">
                  <a:txBody>
                    <a:bodyPr/>
                    <a:lstStyle/>
                    <a:p>
                      <a:r>
                        <a:rPr lang="en-GB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 Table </a:t>
                      </a:r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 Crystallographic data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97783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200"/>
                        </a:spcAft>
                      </a:pPr>
                      <a:r>
                        <a:rPr lang="en-GB" sz="11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ampl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eam line (synchrotron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etector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Space group/protomers per 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.u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. 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ell constants (a, b, c, in 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Å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; β in º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Wavelength (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Å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. of measurements / unique reflection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esolution range (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Å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(outermost shell) 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ompleteness (%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</a:t>
                      </a:r>
                      <a:r>
                        <a:rPr lang="en-GB" sz="1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erge</a:t>
                      </a:r>
                      <a:r>
                        <a:rPr lang="en-GB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</a:t>
                      </a:r>
                      <a:r>
                        <a:rPr lang="en-GB" sz="1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eas</a:t>
                      </a:r>
                      <a:r>
                        <a:rPr lang="en-GB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C(</a:t>
                      </a:r>
                      <a:r>
                        <a:rPr lang="en-GB" sz="10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/</a:t>
                      </a:r>
                      <a:r>
                        <a:rPr lang="en-GB" sz="10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c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verage intensity 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-Factor (Wilson) (Å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ver. Multiplicity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rocessing softwar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. of reflections used in refinement [in test set]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rystallographic 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</a:t>
                      </a:r>
                      <a:r>
                        <a:rPr lang="en-GB" sz="1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actor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/free 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</a:t>
                      </a:r>
                      <a:r>
                        <a:rPr lang="en-GB" sz="1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actor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r>
                        <a:rPr lang="en-GB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obs 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, </a:t>
                      </a: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</a:t>
                      </a:r>
                      <a:r>
                        <a:rPr lang="en-GB" sz="1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alc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correlation [test set]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esidues with RSRZ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a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&gt; 2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No. of protein residues/atoms/solvent molecules/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non-covalent ligand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msd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from target value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bonds/angles/chirality/planarity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verage B-factors (Å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: protein/ligands/solvent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l-atom contacts and geometry analysi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Protein residue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in favoured Ramachandran regions/outliers/all residue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with outlying rotamers/bonds/angles/chirality/planarity/Cβ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ll-atom clashes/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lashscore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/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olprobity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scor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rotein residues in multiple conformation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DB access cod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200"/>
                        </a:spcAft>
                      </a:pPr>
                      <a:r>
                        <a:rPr lang="en-GB" sz="1100" b="1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T. </a:t>
                      </a:r>
                      <a:r>
                        <a:rPr lang="en-GB" sz="1100" b="1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amosa</a:t>
                      </a:r>
                      <a:r>
                        <a:rPr lang="en-GB" sz="1100" b="1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IgAse2–4 (328 – 876+E</a:t>
                      </a:r>
                      <a:r>
                        <a:rPr lang="en-GB" sz="1100" b="1" i="1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40</a:t>
                      </a:r>
                      <a:r>
                        <a:rPr lang="en-GB" sz="1100" b="1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L13 XALOC (ALBA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ilatus3 X 6M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P2</a:t>
                      </a:r>
                      <a:r>
                        <a:rPr lang="en-GB" sz="1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/ 1 (chain A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6.15, 87.83, 67.47, 96.1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9792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42,449 / 53,46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5.9 – 1.75 (1.86 – 1.75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99.1 (96.0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077 (1.563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083 (1.750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999 (0.458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3.3 (1.2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9.5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6.4 (4.9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ds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/ </a:t>
                      </a: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scal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2,759 [701]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178 / 0.213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968 [0.955]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 (0.7%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48 / 4409 / 430 /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 Zn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+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, 1 FMT, 1 PG4, 8 EDO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0.012 / 1.299 / 0.078 / 0.01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35.4 / 52.0 / 45.1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33 (96.9%) / 0 / 55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  <a:tabLst>
                          <a:tab pos="2070100" algn="l"/>
                        </a:tabLs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5 (1.0%) / 0 / 0 / 0 / 0 / 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                15 / 1.6 / 1.2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                   2 (0.4%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                          9I4Z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1520220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Abbreviations: </a:t>
                      </a:r>
                      <a:r>
                        <a:rPr lang="en-GB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a.u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., crystallographic asymmetric unit; FMT, </a:t>
                      </a:r>
                      <a:r>
                        <a:rPr lang="en-GB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formate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(HCOO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Calibri" panose="020F0502020204030204" pitchFamily="34" charset="0"/>
                          <a:cs typeface="Cambria Math" panose="02040503050406030204" pitchFamily="18" charset="0"/>
                        </a:rPr>
                        <a:t>⊖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; PG4, </a:t>
                      </a:r>
                      <a:r>
                        <a:rPr lang="en-GB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tetraethylene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glycol (OH–[CH</a:t>
                      </a:r>
                      <a:r>
                        <a:rPr lang="en-GB" sz="1100" kern="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–CH</a:t>
                      </a:r>
                      <a:r>
                        <a:rPr lang="en-GB" sz="1100" kern="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–O]</a:t>
                      </a:r>
                      <a:r>
                        <a:rPr lang="en-GB" sz="1100" kern="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4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–H); EDO, ethylene glycol (OH–CH</a:t>
                      </a:r>
                      <a:r>
                        <a:rPr lang="en-GB" sz="1100" kern="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–CH</a:t>
                      </a:r>
                      <a:r>
                        <a:rPr lang="en-GB" sz="1100" kern="10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–OH); RSRZ, real space </a:t>
                      </a:r>
                      <a:r>
                        <a:rPr lang="en-GB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R</a:t>
                      </a:r>
                      <a:r>
                        <a:rPr lang="en-GB" sz="1100" kern="100" baseline="-25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value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normalised against residue type and resolution (Fourier-map outliers). 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b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Values in parentheses refer to the outermost resolution shell. 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c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For definitions, see 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1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. 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Average intensity is &lt; I/</a:t>
                      </a:r>
                      <a:r>
                        <a:rPr lang="en-GB" sz="11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σ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I) &gt; of unique reflections after merging according to </a:t>
                      </a:r>
                      <a:r>
                        <a:rPr lang="en-GB" sz="1100" i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Xscale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GB" sz="1100" kern="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2</a:t>
                      </a:r>
                      <a:r>
                        <a:rPr lang="en-GB" sz="11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. Validation according to the wwPDB Deposition Service (https://deposit-1.wwpdb.org/deposition).</a:t>
                      </a:r>
                      <a:endParaRPr lang="en-ES" sz="11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ES" sz="11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086384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8862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075</TotalTime>
  <Words>478</Words>
  <Application>Microsoft Macintosh PowerPoint</Application>
  <PresentationFormat>A4 Paper (210x297 mm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.X.Gomis-Rüth</dc:creator>
  <cp:lastModifiedBy>F.X.Gomis-Rüth</cp:lastModifiedBy>
  <cp:revision>406</cp:revision>
  <dcterms:created xsi:type="dcterms:W3CDTF">2024-01-16T16:15:53Z</dcterms:created>
  <dcterms:modified xsi:type="dcterms:W3CDTF">2025-06-18T09:53:02Z</dcterms:modified>
</cp:coreProperties>
</file>